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-264" y="-29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834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642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89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945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72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55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06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714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482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532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183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50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8AEDA73-AF78-47D9-B60B-EB0F2453E7DA}"/>
              </a:ext>
            </a:extLst>
          </p:cNvPr>
          <p:cNvSpPr txBox="1"/>
          <p:nvPr/>
        </p:nvSpPr>
        <p:spPr>
          <a:xfrm>
            <a:off x="757000" y="5382461"/>
            <a:ext cx="5344000" cy="10688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692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 Repartition and correlation of  zinc concentration (Zn), grain yield (GY), straw weight (SWt) and heading date (HD) across the 2 sites (Ankazomiriotra AZ and Anjiro AJ). The broad sense heritability is shown above each trai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5C869E9-F33F-4323-84FC-1C77FB92D3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9241" y="1404790"/>
            <a:ext cx="3647472" cy="36474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5A97470-CF3C-4CC4-90AB-A7BA55A9D72E}"/>
              </a:ext>
            </a:extLst>
          </p:cNvPr>
          <p:cNvSpPr txBox="1"/>
          <p:nvPr/>
        </p:nvSpPr>
        <p:spPr>
          <a:xfrm>
            <a:off x="1833829" y="1220652"/>
            <a:ext cx="665567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H</a:t>
            </a:r>
            <a:r>
              <a:rPr lang="en-US" sz="969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</a:t>
            </a:r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 = 0.79</a:t>
            </a:r>
            <a:endParaRPr lang="en-US" sz="969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CC07ACA-9660-42EA-A34A-B38746068CB5}"/>
              </a:ext>
            </a:extLst>
          </p:cNvPr>
          <p:cNvSpPr txBox="1"/>
          <p:nvPr/>
        </p:nvSpPr>
        <p:spPr>
          <a:xfrm>
            <a:off x="3531315" y="1217902"/>
            <a:ext cx="665567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H</a:t>
            </a:r>
            <a:r>
              <a:rPr lang="en-US" sz="969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</a:t>
            </a:r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 = 0.49</a:t>
            </a:r>
            <a:endParaRPr lang="en-US" sz="969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273B06-ED03-44DE-8813-8CA7D4034D12}"/>
              </a:ext>
            </a:extLst>
          </p:cNvPr>
          <p:cNvSpPr txBox="1"/>
          <p:nvPr/>
        </p:nvSpPr>
        <p:spPr>
          <a:xfrm>
            <a:off x="2685324" y="1217902"/>
            <a:ext cx="665567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H</a:t>
            </a:r>
            <a:r>
              <a:rPr lang="en-US" sz="969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</a:t>
            </a:r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 = 0.40</a:t>
            </a:r>
            <a:endParaRPr lang="en-US" sz="969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4F9998-0D4C-4A8F-BF32-007C1431F32C}"/>
              </a:ext>
            </a:extLst>
          </p:cNvPr>
          <p:cNvSpPr txBox="1"/>
          <p:nvPr/>
        </p:nvSpPr>
        <p:spPr>
          <a:xfrm>
            <a:off x="4357754" y="1217902"/>
            <a:ext cx="665567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H</a:t>
            </a:r>
            <a:r>
              <a:rPr lang="en-US" sz="969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</a:t>
            </a:r>
            <a:r>
              <a:rPr lang="en-US" sz="969" dirty="0">
                <a:latin typeface="Times New Roman" panose="02020603050405020304" pitchFamily="18" charset="0"/>
                <a:ea typeface="MS Mincho" panose="02020609040205080304" pitchFamily="49" charset="-128"/>
              </a:rPr>
              <a:t> = 0.92</a:t>
            </a:r>
            <a:endParaRPr lang="en-US" sz="969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1698E4A-64C4-4AC9-B396-E73E976C4670}"/>
              </a:ext>
            </a:extLst>
          </p:cNvPr>
          <p:cNvSpPr txBox="1"/>
          <p:nvPr/>
        </p:nvSpPr>
        <p:spPr>
          <a:xfrm>
            <a:off x="757000" y="6451280"/>
            <a:ext cx="5504100" cy="9205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692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prediction of zinc-biofortification potential in rice gene bank accessions</a:t>
            </a:r>
          </a:p>
          <a:p>
            <a:pPr>
              <a:lnSpc>
                <a:spcPct val="115000"/>
              </a:lnSpc>
              <a:spcAft>
                <a:spcPts val="692"/>
              </a:spcAft>
            </a:pP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kotondramanan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et al. (2022) Theoretical and </a:t>
            </a:r>
            <a:r>
              <a:rPr lang="en-US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plied Genetics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692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Matthia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ssuw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issuwa@affrc.go.jp</a:t>
            </a:r>
          </a:p>
        </p:txBody>
      </p:sp>
    </p:spTree>
    <p:extLst>
      <p:ext uri="{BB962C8B-B14F-4D97-AF65-F5344CB8AC3E}">
        <p14:creationId xmlns:p14="http://schemas.microsoft.com/office/powerpoint/2010/main" val="154802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</TotalTime>
  <Words>95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Juan</cp:lastModifiedBy>
  <cp:revision>32</cp:revision>
  <dcterms:created xsi:type="dcterms:W3CDTF">2021-06-16T10:29:06Z</dcterms:created>
  <dcterms:modified xsi:type="dcterms:W3CDTF">2022-04-12T01:42:15Z</dcterms:modified>
</cp:coreProperties>
</file>